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6304D8-5E36-436D-8299-185126BF22B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9967F2-86B3-4C01-A7E3-3A8C86EAC7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E6A30B-FF82-4ACE-96F4-71E07437B99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293407-5D41-49CF-9A25-6627BF1BAB9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4189A2-F63C-4B04-A9ED-4487D19557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9C185A-2C14-4B06-A98C-3B455B2851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747191-FD3B-402B-8164-8C911607F5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4CEAD6-A823-4F0A-AD85-07378F064E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C808AC-7DAA-4993-82E2-607D5D08CB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A3CA36-A9BB-4831-8A09-8FA2DBC0C2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00C81D-6FFF-41C4-816A-357B2C391F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B4FD05-DEA2-492B-9361-7E3FEB1AD6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75C221-DBFC-42C5-A739-22611E2C0FFB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1476360" y="189000"/>
            <a:ext cx="6191280" cy="5611680"/>
          </a:xfrm>
          <a:prstGeom prst="rect">
            <a:avLst/>
          </a:prstGeom>
          <a:ln w="0">
            <a:noFill/>
          </a:ln>
        </p:spPr>
      </p:pic>
      <p:sp>
        <p:nvSpPr>
          <p:cNvPr id="42" name="TextBox 3"/>
          <p:cNvSpPr/>
          <p:nvPr/>
        </p:nvSpPr>
        <p:spPr>
          <a:xfrm>
            <a:off x="1332000" y="5877000"/>
            <a:ext cx="6696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Supplementary Figure S6: 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MLL-PTD identified by ExomeCopy analysis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Localised +1 copy number gain around the genomic region containing exons 2-9 of the gene MLL (light blue dots), which was subsequently shown to be due to an MLL-PTD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3-15T18:57:28Z</dcterms:created>
  <dc:creator>George S. Vassiliou</dc:creator>
  <dc:description/>
  <dc:language>en-US</dc:language>
  <cp:lastModifiedBy>S.Bramaramba</cp:lastModifiedBy>
  <dcterms:modified xsi:type="dcterms:W3CDTF">2013-05-20T06:01:11Z</dcterms:modified>
  <cp:revision>5</cp:revision>
  <dc:subject/>
  <dc:title>PowerPoint Presentation</dc:title>
</cp:coreProperties>
</file>